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bert Chemelewski" initials="RC" lastIdx="1" clrIdx="0">
    <p:extLst>
      <p:ext uri="{19B8F6BF-5375-455C-9EA6-DF929625EA0E}">
        <p15:presenceInfo xmlns:p15="http://schemas.microsoft.com/office/powerpoint/2012/main" userId="e8a550d334cd12d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6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9A0097-5800-AB37-37C1-7A193ABEF9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87A1522-ECB2-AB1B-4719-41C68B6423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10EEEC-852D-86EE-E0B4-8EDD0C82A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3F7D8-5864-4E51-BE08-03C56C2DB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8D0165-241F-F934-6695-5EC66264E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333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643EC5-A59F-0866-312D-AE200F04E8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AAE128-2ABE-69F9-455F-298B36C850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4438A3-631D-A3A1-A742-BE479AE5E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CF3D18-0616-64A1-22F3-CD69371FF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628931-C5A0-4DB5-F717-A1B7FF08E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226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3BC91D0-DAB5-3556-B6A2-0ADE6E7A41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649C1F-4B7A-7D97-68F1-92FE7A9634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EC7E26-3F51-4D73-E973-B9508A0E8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184EAF-FD32-62F6-B082-4CEF0B67B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522BA8-487B-1825-C10D-BCFBAD33C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429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429981-C582-B30D-EDE9-6B430B7A1E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195D94-9E4E-03B5-393C-97CD62FC7E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31C74F-ACD8-3850-330E-9E98AD70E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B33387-0AF5-A511-A33E-264B29433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E61FD8-A21D-02D9-E0E5-21B0FB0EA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132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873963-37AA-71B3-7EBF-32462D1CC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68C44E-A601-6DF5-FC3E-BB2959A012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90A5CC-F4F3-37A7-EF92-55C4B4E70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A3371F-4703-01B9-D6E5-C4C901563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E127EF-88A6-0394-FA8B-992E48F68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876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0FFF8F-5E5D-11C0-A4BD-E23F517FD9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41D02B-629C-B895-0623-3ECF856EF1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7A3C41-7877-366F-D221-5BB8EFFB36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A941D4-C72A-1811-23B9-626B24849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A09CD-5039-D5F9-3B29-261C6328D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0EC745-DCF2-69B3-4DBA-C5DE039D6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376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E69C2-7AF2-AB10-2AB8-46D0EA924A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C03C01-F7A1-6672-CE9F-FE3D5F2080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8BD65A-E212-BA28-0511-D036D90EEA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B0BF4D3-BB4D-02C7-A91C-C1B5F11A8D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86987F-3AA3-05C5-105C-9DAAA8A9AF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C2D4C5-1FDD-42BA-FA84-F4C272C10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F68F2CB-CAA6-F214-CCEE-6E1DF007A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9CA7CF-1BDA-600A-9CBA-B7DE681BA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224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CE58D3-441E-9371-E1A3-0900367C4E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DD9C29-2D63-2C70-E358-13AB19E74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107224-AEFF-2019-9AE5-B44BEB552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A77B19-57F3-5848-AE40-856035BD4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494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36466D-6116-F6F9-EE6D-CE32EDD43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137B97-E4B5-20C4-2A78-09E21798F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F6B42A-AD18-CABE-E59F-06A0101B7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962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C6A3CB-EF09-8F3E-B80A-E873FFB66B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B45849-36BD-F2F0-56F5-FF16FDAC8E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350153-CAB3-2D12-378A-3BDB648ED1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0E3D73-215B-0A29-6A80-B8778DB1B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EBFCB2-8EAE-F05D-F00E-0DAFE542F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9D70BC-AE19-1ABC-6EEF-B590D627F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751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663285-3151-F62F-3DAC-347E593EF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D0988E-674E-3529-C119-EE57F62FB0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62B05E-07C2-C50F-4085-B0290E73AF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D1CFBD-43E5-7FDA-7C3C-EBC7490F3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B1FF09-3492-9358-13A1-6E8F611C0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C287E0-948A-6A5F-1852-BD840193E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664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9D0350-6BBB-0324-E14B-C570583935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707A77-29E0-00F4-4191-20A8DF42F1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2F6BC-AEBF-710A-671D-931FD00DCA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A4FFEF-0ECB-D3FC-85AA-EF2D0085A0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EFCB79-A4B8-D9C8-93CA-7BA4AC2841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169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Relationship Id="rId9" Type="http://schemas.openxmlformats.org/officeDocument/2006/relationships/image" Target="../media/image8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Graphic 14">
            <a:extLst>
              <a:ext uri="{FF2B5EF4-FFF2-40B4-BE49-F238E27FC236}">
                <a16:creationId xmlns:a16="http://schemas.microsoft.com/office/drawing/2014/main" id="{917C5BF0-924B-1888-C982-F0CDA9C70EC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r="26081"/>
          <a:stretch/>
        </p:blipFill>
        <p:spPr>
          <a:xfrm>
            <a:off x="5089230" y="74208"/>
            <a:ext cx="2087729" cy="1825129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3771DA2-4CE2-5E4F-9545-3D5B5E208D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51769" y="809009"/>
            <a:ext cx="4198256" cy="682624"/>
          </a:xfrm>
        </p:spPr>
        <p:txBody>
          <a:bodyPr>
            <a:normAutofit fontScale="90000"/>
          </a:bodyPr>
          <a:lstStyle/>
          <a:p>
            <a:br>
              <a:rPr lang="en-US" dirty="0"/>
            </a:br>
            <a:r>
              <a:rPr lang="en-US" dirty="0"/>
              <a:t>Supplemental Figure 8</a:t>
            </a:r>
            <a:br>
              <a:rPr lang="en-US" dirty="0"/>
            </a:br>
            <a:endParaRPr lang="en-US" dirty="0"/>
          </a:p>
        </p:txBody>
      </p:sp>
      <p:pic>
        <p:nvPicPr>
          <p:cNvPr id="6" name="Graphic 5">
            <a:extLst>
              <a:ext uri="{FF2B5EF4-FFF2-40B4-BE49-F238E27FC236}">
                <a16:creationId xmlns:a16="http://schemas.microsoft.com/office/drawing/2014/main" id="{29FAF967-18E2-4C92-A6C9-1A11B2E8893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 r="26632"/>
          <a:stretch/>
        </p:blipFill>
        <p:spPr>
          <a:xfrm>
            <a:off x="5078442" y="1712340"/>
            <a:ext cx="2087728" cy="1676858"/>
          </a:xfrm>
          <a:prstGeom prst="rect">
            <a:avLst/>
          </a:prstGeom>
        </p:spPr>
      </p:pic>
      <p:pic>
        <p:nvPicPr>
          <p:cNvPr id="7" name="Graphic 6">
            <a:extLst>
              <a:ext uri="{FF2B5EF4-FFF2-40B4-BE49-F238E27FC236}">
                <a16:creationId xmlns:a16="http://schemas.microsoft.com/office/drawing/2014/main" id="{CC7D6E6A-5A31-46F4-97DC-8E2A08944DD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rcRect r="26081"/>
          <a:stretch/>
        </p:blipFill>
        <p:spPr>
          <a:xfrm>
            <a:off x="5084341" y="3245595"/>
            <a:ext cx="2103408" cy="1676858"/>
          </a:xfrm>
          <a:prstGeom prst="rect">
            <a:avLst/>
          </a:prstGeom>
        </p:spPr>
      </p:pic>
      <p:pic>
        <p:nvPicPr>
          <p:cNvPr id="9" name="Graphic 8">
            <a:extLst>
              <a:ext uri="{FF2B5EF4-FFF2-40B4-BE49-F238E27FC236}">
                <a16:creationId xmlns:a16="http://schemas.microsoft.com/office/drawing/2014/main" id="{7973404D-D972-4B6D-80BC-205C91AF41A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rcRect r="26632"/>
          <a:stretch/>
        </p:blipFill>
        <p:spPr>
          <a:xfrm>
            <a:off x="5059976" y="4840334"/>
            <a:ext cx="2087728" cy="167685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5961336-9D03-4A7E-8546-5D5C713D75B0}"/>
              </a:ext>
            </a:extLst>
          </p:cNvPr>
          <p:cNvSpPr txBox="1"/>
          <p:nvPr/>
        </p:nvSpPr>
        <p:spPr>
          <a:xfrm>
            <a:off x="5334886" y="14600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  <a:endParaRPr lang="en-US" sz="2400" b="1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30CF49CB-F947-4376-A8B5-3DE2D9B09E80}"/>
              </a:ext>
            </a:extLst>
          </p:cNvPr>
          <p:cNvSpPr/>
          <p:nvPr/>
        </p:nvSpPr>
        <p:spPr>
          <a:xfrm>
            <a:off x="5339695" y="1822862"/>
            <a:ext cx="314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70828E8-D382-49B8-B16E-F3A1F74679F9}"/>
              </a:ext>
            </a:extLst>
          </p:cNvPr>
          <p:cNvSpPr/>
          <p:nvPr/>
        </p:nvSpPr>
        <p:spPr>
          <a:xfrm>
            <a:off x="5343703" y="3270357"/>
            <a:ext cx="3064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C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0C3DCA55-D70A-89F5-714B-F694DA49F67E}"/>
              </a:ext>
            </a:extLst>
          </p:cNvPr>
          <p:cNvCxnSpPr>
            <a:cxnSpLocks/>
          </p:cNvCxnSpPr>
          <p:nvPr/>
        </p:nvCxnSpPr>
        <p:spPr>
          <a:xfrm flipH="1" flipV="1">
            <a:off x="6833766" y="340808"/>
            <a:ext cx="12398" cy="6045768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41125D4-A99B-66A9-71B6-42CE4246818D}"/>
              </a:ext>
            </a:extLst>
          </p:cNvPr>
          <p:cNvCxnSpPr>
            <a:cxnSpLocks/>
          </p:cNvCxnSpPr>
          <p:nvPr/>
        </p:nvCxnSpPr>
        <p:spPr>
          <a:xfrm flipV="1">
            <a:off x="6378804" y="330670"/>
            <a:ext cx="0" cy="6015266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FA714959-6354-7C30-307F-9716E8D8C7B4}"/>
              </a:ext>
            </a:extLst>
          </p:cNvPr>
          <p:cNvCxnSpPr>
            <a:cxnSpLocks/>
          </p:cNvCxnSpPr>
          <p:nvPr/>
        </p:nvCxnSpPr>
        <p:spPr>
          <a:xfrm flipH="1">
            <a:off x="6382812" y="3894062"/>
            <a:ext cx="901908" cy="70841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083DA835-A28D-A163-E101-F1E131C455DC}"/>
              </a:ext>
            </a:extLst>
          </p:cNvPr>
          <p:cNvSpPr txBox="1"/>
          <p:nvPr/>
        </p:nvSpPr>
        <p:spPr>
          <a:xfrm>
            <a:off x="7280974" y="3515880"/>
            <a:ext cx="2639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ldehydes Start to Appear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353A85D3-05D7-609A-447E-FEB69BE613F0}"/>
              </a:ext>
            </a:extLst>
          </p:cNvPr>
          <p:cNvCxnSpPr>
            <a:cxnSpLocks/>
          </p:cNvCxnSpPr>
          <p:nvPr/>
        </p:nvCxnSpPr>
        <p:spPr>
          <a:xfrm flipH="1">
            <a:off x="6194852" y="2085505"/>
            <a:ext cx="1086122" cy="97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5892A56A-1C78-4231-1D32-624726F2C82C}"/>
              </a:ext>
            </a:extLst>
          </p:cNvPr>
          <p:cNvSpPr txBox="1"/>
          <p:nvPr/>
        </p:nvSpPr>
        <p:spPr>
          <a:xfrm>
            <a:off x="7280974" y="1773514"/>
            <a:ext cx="24603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lcohols Start to Appear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5717739B-C697-47C5-C9FD-AE46A1641A3D}"/>
              </a:ext>
            </a:extLst>
          </p:cNvPr>
          <p:cNvCxnSpPr>
            <a:cxnSpLocks/>
          </p:cNvCxnSpPr>
          <p:nvPr/>
        </p:nvCxnSpPr>
        <p:spPr>
          <a:xfrm flipH="1">
            <a:off x="6596803" y="2127131"/>
            <a:ext cx="1086122" cy="97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A8B3AB29-8646-F6B1-220D-2DE314E32941}"/>
              </a:ext>
            </a:extLst>
          </p:cNvPr>
          <p:cNvCxnSpPr>
            <a:cxnSpLocks/>
          </p:cNvCxnSpPr>
          <p:nvPr/>
        </p:nvCxnSpPr>
        <p:spPr>
          <a:xfrm flipH="1">
            <a:off x="6859280" y="3888857"/>
            <a:ext cx="901908" cy="70841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3A214F54-B794-60D7-9833-E0742FF8ED6F}"/>
              </a:ext>
            </a:extLst>
          </p:cNvPr>
          <p:cNvSpPr txBox="1"/>
          <p:nvPr/>
        </p:nvSpPr>
        <p:spPr>
          <a:xfrm>
            <a:off x="3605292" y="2390431"/>
            <a:ext cx="1282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ternode 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40B9F6E-A879-1B38-B075-9431A8D236E1}"/>
              </a:ext>
            </a:extLst>
          </p:cNvPr>
          <p:cNvSpPr txBox="1"/>
          <p:nvPr/>
        </p:nvSpPr>
        <p:spPr>
          <a:xfrm>
            <a:off x="3605292" y="3873369"/>
            <a:ext cx="1282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ternode 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61C7D0C-23CA-85CA-5887-94FA13CE4366}"/>
              </a:ext>
            </a:extLst>
          </p:cNvPr>
          <p:cNvSpPr txBox="1"/>
          <p:nvPr/>
        </p:nvSpPr>
        <p:spPr>
          <a:xfrm>
            <a:off x="3605292" y="5491634"/>
            <a:ext cx="1399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ternode 25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212808B9-34E4-A845-F0E6-06B23333D51B}"/>
              </a:ext>
            </a:extLst>
          </p:cNvPr>
          <p:cNvSpPr/>
          <p:nvPr/>
        </p:nvSpPr>
        <p:spPr>
          <a:xfrm>
            <a:off x="5390495" y="4891182"/>
            <a:ext cx="3305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563FBBC-8BA0-7ABD-8B5B-2A54F83CCB74}"/>
              </a:ext>
            </a:extLst>
          </p:cNvPr>
          <p:cNvSpPr txBox="1"/>
          <p:nvPr/>
        </p:nvSpPr>
        <p:spPr>
          <a:xfrm>
            <a:off x="3605292" y="739079"/>
            <a:ext cx="1282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ternode 2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BC7BBC96-4B79-7318-73CF-C0052DDBD7B1}"/>
              </a:ext>
            </a:extLst>
          </p:cNvPr>
          <p:cNvCxnSpPr>
            <a:cxnSpLocks/>
          </p:cNvCxnSpPr>
          <p:nvPr/>
        </p:nvCxnSpPr>
        <p:spPr>
          <a:xfrm flipH="1">
            <a:off x="5931962" y="593876"/>
            <a:ext cx="1086122" cy="970513"/>
          </a:xfrm>
          <a:prstGeom prst="straightConnector1">
            <a:avLst/>
          </a:prstGeom>
          <a:ln>
            <a:solidFill>
              <a:srgbClr val="7030A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F8A7F033-67E8-20AE-A423-D76CF3AABA14}"/>
              </a:ext>
            </a:extLst>
          </p:cNvPr>
          <p:cNvSpPr txBox="1"/>
          <p:nvPr/>
        </p:nvSpPr>
        <p:spPr>
          <a:xfrm>
            <a:off x="7310234" y="330670"/>
            <a:ext cx="1343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Nonacosan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66983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6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 Supplemental Figure 8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Chemelewski</dc:creator>
  <cp:lastModifiedBy>Abby Rassette</cp:lastModifiedBy>
  <cp:revision>4</cp:revision>
  <dcterms:created xsi:type="dcterms:W3CDTF">2023-05-23T18:35:33Z</dcterms:created>
  <dcterms:modified xsi:type="dcterms:W3CDTF">2023-09-11T14:26:42Z</dcterms:modified>
</cp:coreProperties>
</file>